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67" r:id="rId4"/>
    <p:sldId id="257" r:id="rId5"/>
    <p:sldId id="26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eena.Ghildyal" initials="R" lastIdx="1" clrIdx="0">
    <p:extLst>
      <p:ext uri="{19B8F6BF-5375-455C-9EA6-DF929625EA0E}">
        <p15:presenceInfo xmlns:p15="http://schemas.microsoft.com/office/powerpoint/2012/main" userId="S::Reena.Ghildyal@canberra.edu.au::2bf3b119-6495-46f1-8ad1-28bb66bc4d1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E1E1"/>
    <a:srgbClr val="DADADA"/>
    <a:srgbClr val="DCDCDC"/>
    <a:srgbClr val="D7D7D7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738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1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69486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6461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8495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6043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0415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5843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65967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25935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90389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54478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92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8B248-E6E6-4BB3-87BD-6393EDBC80A5}" type="datetimeFigureOut">
              <a:rPr lang="en-AU" smtClean="0"/>
              <a:t>23/08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7CA5C-8E45-4F08-874D-7E074DEA66A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4280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E8614C0F-0AEA-410F-99DC-8207DD89BA1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50" t="23870" r="39496" b="17501"/>
          <a:stretch/>
        </p:blipFill>
        <p:spPr>
          <a:xfrm>
            <a:off x="827742" y="4871528"/>
            <a:ext cx="2223228" cy="3407175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51F505A3-3406-4B74-BAB3-D298B252DD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3077" y="1281258"/>
            <a:ext cx="2032558" cy="3391642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1B58C7A4-CC89-4B42-9609-DD47B4BF7F3F}"/>
              </a:ext>
            </a:extLst>
          </p:cNvPr>
          <p:cNvSpPr txBox="1"/>
          <p:nvPr/>
        </p:nvSpPr>
        <p:spPr>
          <a:xfrm>
            <a:off x="2569052" y="5183283"/>
            <a:ext cx="420308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0</a:t>
            </a:r>
          </a:p>
          <a:p>
            <a:r>
              <a:rPr lang="en-US" sz="1200" b="1" dirty="0"/>
              <a:t>125</a:t>
            </a:r>
          </a:p>
          <a:p>
            <a:r>
              <a:rPr lang="en-US" sz="1200" b="1" dirty="0"/>
              <a:t>80</a:t>
            </a:r>
          </a:p>
          <a:p>
            <a:endParaRPr lang="en-US" sz="1200" b="1" dirty="0"/>
          </a:p>
          <a:p>
            <a:r>
              <a:rPr lang="en-US" sz="1200" b="1" dirty="0"/>
              <a:t>50</a:t>
            </a:r>
          </a:p>
          <a:p>
            <a:endParaRPr lang="en-US" sz="1200" b="1" dirty="0"/>
          </a:p>
          <a:p>
            <a:r>
              <a:rPr lang="en-US" sz="1200" b="1" dirty="0"/>
              <a:t>40</a:t>
            </a:r>
          </a:p>
          <a:p>
            <a:endParaRPr lang="en-US" sz="1200" b="1" dirty="0"/>
          </a:p>
          <a:p>
            <a:endParaRPr lang="en-US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6D76585-DED7-452A-8CC9-18C4085D0BE4}"/>
              </a:ext>
            </a:extLst>
          </p:cNvPr>
          <p:cNvSpPr txBox="1"/>
          <p:nvPr/>
        </p:nvSpPr>
        <p:spPr>
          <a:xfrm>
            <a:off x="106268" y="66799"/>
            <a:ext cx="2756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</a:t>
            </a:r>
            <a:endParaRPr lang="en-AU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C05BABA-1458-4388-820C-C9E446817515}"/>
              </a:ext>
            </a:extLst>
          </p:cNvPr>
          <p:cNvSpPr txBox="1"/>
          <p:nvPr/>
        </p:nvSpPr>
        <p:spPr>
          <a:xfrm>
            <a:off x="410165" y="894070"/>
            <a:ext cx="9148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4 h.p.t</a:t>
            </a:r>
            <a:endParaRPr lang="en-AU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974C3D0-DA5D-4BA0-849B-EC693F063566}"/>
              </a:ext>
            </a:extLst>
          </p:cNvPr>
          <p:cNvSpPr txBox="1"/>
          <p:nvPr/>
        </p:nvSpPr>
        <p:spPr>
          <a:xfrm rot="18613556">
            <a:off x="1118252" y="504478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MSO</a:t>
            </a:r>
            <a:endParaRPr lang="en-AU" sz="12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5DBE0CC-55AC-44D4-B874-3917060515DA}"/>
              </a:ext>
            </a:extLst>
          </p:cNvPr>
          <p:cNvSpPr txBox="1"/>
          <p:nvPr/>
        </p:nvSpPr>
        <p:spPr>
          <a:xfrm rot="18613556">
            <a:off x="1379695" y="5004051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35</a:t>
            </a:r>
            <a:endParaRPr lang="en-AU" sz="1200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3D3C01A-8D70-41F7-9461-A3B9E831D4C6}"/>
              </a:ext>
            </a:extLst>
          </p:cNvPr>
          <p:cNvSpPr txBox="1"/>
          <p:nvPr/>
        </p:nvSpPr>
        <p:spPr>
          <a:xfrm rot="18613556">
            <a:off x="1652804" y="5030820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185</a:t>
            </a:r>
            <a:endParaRPr lang="en-AU" sz="1200" b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2DC502B-434F-4096-B727-A1EB2BA9D780}"/>
              </a:ext>
            </a:extLst>
          </p:cNvPr>
          <p:cNvSpPr txBox="1"/>
          <p:nvPr/>
        </p:nvSpPr>
        <p:spPr>
          <a:xfrm rot="18613556">
            <a:off x="1961759" y="5010661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01</a:t>
            </a:r>
            <a:endParaRPr lang="en-AU" sz="120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F1F899D-B9DC-4023-A1F6-638CBC2AE5BA}"/>
              </a:ext>
            </a:extLst>
          </p:cNvPr>
          <p:cNvSpPr txBox="1"/>
          <p:nvPr/>
        </p:nvSpPr>
        <p:spPr>
          <a:xfrm>
            <a:off x="384219" y="5950252"/>
            <a:ext cx="66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ubulin</a:t>
            </a:r>
            <a:endParaRPr lang="en-AU" sz="1200" b="1" dirty="0"/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BC5C128B-7CF0-4CCD-BA2B-15FF2E18043D}"/>
              </a:ext>
            </a:extLst>
          </p:cNvPr>
          <p:cNvCxnSpPr>
            <a:cxnSpLocks/>
          </p:cNvCxnSpPr>
          <p:nvPr/>
        </p:nvCxnSpPr>
        <p:spPr>
          <a:xfrm>
            <a:off x="1032367" y="6088752"/>
            <a:ext cx="9234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40944B37-926B-4AC6-A0D5-02EE3B6DD811}"/>
              </a:ext>
            </a:extLst>
          </p:cNvPr>
          <p:cNvSpPr txBox="1"/>
          <p:nvPr/>
        </p:nvSpPr>
        <p:spPr>
          <a:xfrm rot="18613556">
            <a:off x="1179034" y="139308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MSO</a:t>
            </a:r>
            <a:endParaRPr lang="en-AU" sz="12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B8DA6C2-8DC4-4D88-BB67-5B1FA6864CF2}"/>
              </a:ext>
            </a:extLst>
          </p:cNvPr>
          <p:cNvSpPr txBox="1"/>
          <p:nvPr/>
        </p:nvSpPr>
        <p:spPr>
          <a:xfrm rot="18613556">
            <a:off x="1404770" y="1335685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35</a:t>
            </a:r>
            <a:endParaRPr lang="en-AU" sz="12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A810604-18E3-42D4-B389-0B56C485EF3E}"/>
              </a:ext>
            </a:extLst>
          </p:cNvPr>
          <p:cNvSpPr txBox="1"/>
          <p:nvPr/>
        </p:nvSpPr>
        <p:spPr>
          <a:xfrm rot="18613556">
            <a:off x="1658166" y="1369288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185</a:t>
            </a:r>
            <a:endParaRPr lang="en-AU" sz="12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9B75F51-392B-43FB-8819-8E7590BD5496}"/>
              </a:ext>
            </a:extLst>
          </p:cNvPr>
          <p:cNvSpPr txBox="1"/>
          <p:nvPr/>
        </p:nvSpPr>
        <p:spPr>
          <a:xfrm rot="18613556">
            <a:off x="1893932" y="1359696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01</a:t>
            </a:r>
            <a:endParaRPr lang="en-AU" sz="1200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57B2BAA-4887-45C1-803D-6166C2A7C56E}"/>
              </a:ext>
            </a:extLst>
          </p:cNvPr>
          <p:cNvSpPr txBox="1"/>
          <p:nvPr/>
        </p:nvSpPr>
        <p:spPr>
          <a:xfrm>
            <a:off x="560681" y="1984848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XPO1</a:t>
            </a:r>
            <a:endParaRPr lang="en-AU" sz="1200" b="1" dirty="0"/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CF83B2FF-B6C7-4CE9-9F82-4404D9B03F17}"/>
              </a:ext>
            </a:extLst>
          </p:cNvPr>
          <p:cNvCxnSpPr>
            <a:cxnSpLocks/>
          </p:cNvCxnSpPr>
          <p:nvPr/>
        </p:nvCxnSpPr>
        <p:spPr>
          <a:xfrm>
            <a:off x="1103324" y="2118251"/>
            <a:ext cx="9234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DF94919A-7619-411B-BB13-CA1E904CF807}"/>
              </a:ext>
            </a:extLst>
          </p:cNvPr>
          <p:cNvSpPr txBox="1"/>
          <p:nvPr/>
        </p:nvSpPr>
        <p:spPr>
          <a:xfrm>
            <a:off x="2331822" y="1594085"/>
            <a:ext cx="420308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0</a:t>
            </a:r>
          </a:p>
          <a:p>
            <a:r>
              <a:rPr lang="en-US" sz="1200" b="1" dirty="0"/>
              <a:t>125</a:t>
            </a:r>
          </a:p>
          <a:p>
            <a:endParaRPr lang="en-US" sz="1200" b="1" dirty="0"/>
          </a:p>
          <a:p>
            <a:r>
              <a:rPr lang="en-US" sz="1200" b="1" dirty="0"/>
              <a:t>80</a:t>
            </a:r>
          </a:p>
          <a:p>
            <a:endParaRPr lang="en-US" sz="1200" b="1" dirty="0"/>
          </a:p>
          <a:p>
            <a:r>
              <a:rPr lang="en-US" sz="1200" b="1" dirty="0"/>
              <a:t>50</a:t>
            </a:r>
          </a:p>
          <a:p>
            <a:endParaRPr lang="en-US" sz="1200" b="1" dirty="0"/>
          </a:p>
          <a:p>
            <a:endParaRPr lang="en-US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F3A2192-4948-4A5C-8B69-00DD9379C862}"/>
              </a:ext>
            </a:extLst>
          </p:cNvPr>
          <p:cNvSpPr txBox="1"/>
          <p:nvPr/>
        </p:nvSpPr>
        <p:spPr>
          <a:xfrm>
            <a:off x="386563" y="1253347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</a:t>
            </a:r>
            <a:r>
              <a:rPr lang="en-US" dirty="0" err="1"/>
              <a:t>i</a:t>
            </a:r>
            <a:r>
              <a:rPr lang="en-US" dirty="0"/>
              <a:t>)</a:t>
            </a:r>
            <a:endParaRPr lang="en-AU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57A0075-5A85-4D82-8CA1-F65923C6F486}"/>
              </a:ext>
            </a:extLst>
          </p:cNvPr>
          <p:cNvSpPr txBox="1"/>
          <p:nvPr/>
        </p:nvSpPr>
        <p:spPr>
          <a:xfrm>
            <a:off x="269978" y="4795726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ii)</a:t>
            </a:r>
            <a:endParaRPr lang="en-AU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8E87A68-4AFE-4CFB-8CAE-FE5FC0F72297}"/>
              </a:ext>
            </a:extLst>
          </p:cNvPr>
          <p:cNvSpPr txBox="1"/>
          <p:nvPr/>
        </p:nvSpPr>
        <p:spPr>
          <a:xfrm>
            <a:off x="109793" y="8778009"/>
            <a:ext cx="663841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ull Length Western blots corresponding to  Figure 2A</a:t>
            </a:r>
          </a:p>
          <a:p>
            <a:r>
              <a:rPr lang="en-US" sz="1200" dirty="0"/>
              <a:t>Please refer to Figure 2 for experimental details. M- </a:t>
            </a:r>
            <a:r>
              <a:rPr lang="en-US" sz="1200" dirty="0" err="1"/>
              <a:t>prestained</a:t>
            </a:r>
            <a:r>
              <a:rPr lang="en-US" sz="1200" dirty="0"/>
              <a:t> marker; Molecular weight in </a:t>
            </a:r>
            <a:r>
              <a:rPr lang="en-US" sz="1200" dirty="0" err="1"/>
              <a:t>kDa</a:t>
            </a:r>
            <a:r>
              <a:rPr lang="en-US" sz="1200" dirty="0"/>
              <a:t> is denoted on the right side of the blot </a:t>
            </a:r>
          </a:p>
          <a:p>
            <a:r>
              <a:rPr lang="en-US" sz="1200" dirty="0"/>
              <a:t>(</a:t>
            </a:r>
            <a:r>
              <a:rPr lang="en-US" sz="1200" dirty="0" err="1"/>
              <a:t>i</a:t>
            </a:r>
            <a:r>
              <a:rPr lang="en-US" sz="1200" dirty="0"/>
              <a:t>) XPO1 at 24 h.p.t, (ii) Tubulin at 24 h.p.t, (iii) </a:t>
            </a:r>
            <a:r>
              <a:rPr lang="en-GB" sz="1200" dirty="0"/>
              <a:t>XPO1 at 48 h.p.t, (iv) A blot for Tubulin at 48 h.p.t that was cut prior to </a:t>
            </a:r>
            <a:r>
              <a:rPr lang="en-GB" sz="1200" dirty="0" err="1"/>
              <a:t>hydridisation</a:t>
            </a:r>
            <a:r>
              <a:rPr lang="en-GB" sz="1200" dirty="0"/>
              <a:t>, (v) Full-length blots for Tubulin at 48 h.p.t with replicate sampl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3C1F6A-A8FE-48B1-8576-53BC3AD2417C}"/>
              </a:ext>
            </a:extLst>
          </p:cNvPr>
          <p:cNvSpPr txBox="1"/>
          <p:nvPr/>
        </p:nvSpPr>
        <p:spPr>
          <a:xfrm>
            <a:off x="2224367" y="1438013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</a:t>
            </a:r>
            <a:endParaRPr lang="en-AU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2FF756-3C5F-4FB9-888A-D5966DD6DD0F}"/>
              </a:ext>
            </a:extLst>
          </p:cNvPr>
          <p:cNvSpPr txBox="1"/>
          <p:nvPr/>
        </p:nvSpPr>
        <p:spPr>
          <a:xfrm>
            <a:off x="2448431" y="5026559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</a:t>
            </a:r>
            <a:endParaRPr lang="en-AU" sz="1200" b="1" dirty="0"/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DE1AE392-82CD-45BC-84C6-7BF015520E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7066" y="545365"/>
            <a:ext cx="2359356" cy="3432345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F5D97607-0DD6-41B7-A1E4-D43829B0F7A1}"/>
              </a:ext>
            </a:extLst>
          </p:cNvPr>
          <p:cNvSpPr txBox="1"/>
          <p:nvPr/>
        </p:nvSpPr>
        <p:spPr>
          <a:xfrm>
            <a:off x="4375723" y="1600686"/>
            <a:ext cx="420308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0</a:t>
            </a:r>
          </a:p>
          <a:p>
            <a:r>
              <a:rPr lang="en-US" sz="1200" b="1" dirty="0"/>
              <a:t>125</a:t>
            </a:r>
          </a:p>
          <a:p>
            <a:r>
              <a:rPr lang="en-US" sz="1200" b="1" dirty="0"/>
              <a:t>80</a:t>
            </a:r>
          </a:p>
          <a:p>
            <a:endParaRPr lang="en-US" sz="1200" b="1" dirty="0"/>
          </a:p>
          <a:p>
            <a:r>
              <a:rPr lang="en-US" sz="1200" b="1" dirty="0"/>
              <a:t>50</a:t>
            </a:r>
          </a:p>
          <a:p>
            <a:endParaRPr lang="en-US" sz="1200" b="1" dirty="0"/>
          </a:p>
          <a:p>
            <a:endParaRPr lang="en-US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83561910-C455-4D0F-ACE3-344699A396C8}"/>
              </a:ext>
            </a:extLst>
          </p:cNvPr>
          <p:cNvGrpSpPr/>
          <p:nvPr/>
        </p:nvGrpSpPr>
        <p:grpSpPr>
          <a:xfrm>
            <a:off x="3698488" y="1777820"/>
            <a:ext cx="652350" cy="276999"/>
            <a:chOff x="304180" y="2594782"/>
            <a:chExt cx="652350" cy="276999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4C318FE-BF3E-4934-B6EF-7BA3AB3C778A}"/>
                </a:ext>
              </a:extLst>
            </p:cNvPr>
            <p:cNvSpPr txBox="1"/>
            <p:nvPr/>
          </p:nvSpPr>
          <p:spPr>
            <a:xfrm>
              <a:off x="304180" y="2594782"/>
              <a:ext cx="5341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XPO1</a:t>
              </a:r>
              <a:endParaRPr lang="en-AU" sz="1200" b="1" dirty="0"/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1C62C634-97A3-4F11-A72E-B219CBBFFD25}"/>
                </a:ext>
              </a:extLst>
            </p:cNvPr>
            <p:cNvCxnSpPr>
              <a:cxnSpLocks/>
            </p:cNvCxnSpPr>
            <p:nvPr/>
          </p:nvCxnSpPr>
          <p:spPr>
            <a:xfrm>
              <a:off x="864184" y="2713744"/>
              <a:ext cx="92346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8C635116-F6E8-4379-9262-AB280CA2D960}"/>
              </a:ext>
            </a:extLst>
          </p:cNvPr>
          <p:cNvSpPr txBox="1"/>
          <p:nvPr/>
        </p:nvSpPr>
        <p:spPr>
          <a:xfrm>
            <a:off x="3318312" y="487371"/>
            <a:ext cx="484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iii)</a:t>
            </a:r>
            <a:endParaRPr lang="en-AU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27A69A6-C3F2-4E0E-9076-5D0E7DF7E30E}"/>
              </a:ext>
            </a:extLst>
          </p:cNvPr>
          <p:cNvSpPr txBox="1"/>
          <p:nvPr/>
        </p:nvSpPr>
        <p:spPr>
          <a:xfrm rot="18613556">
            <a:off x="4778046" y="103475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MSO</a:t>
            </a:r>
            <a:endParaRPr lang="en-AU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CFB36E9-BF1D-492C-8357-1C2C00ADD72B}"/>
              </a:ext>
            </a:extLst>
          </p:cNvPr>
          <p:cNvSpPr txBox="1"/>
          <p:nvPr/>
        </p:nvSpPr>
        <p:spPr>
          <a:xfrm rot="18613556">
            <a:off x="5036491" y="989935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35</a:t>
            </a:r>
            <a:endParaRPr lang="en-AU" sz="12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463450C-079C-4EC1-A86F-F12265DA3C28}"/>
              </a:ext>
            </a:extLst>
          </p:cNvPr>
          <p:cNvSpPr txBox="1"/>
          <p:nvPr/>
        </p:nvSpPr>
        <p:spPr>
          <a:xfrm rot="18613556">
            <a:off x="5275649" y="1017422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185</a:t>
            </a:r>
            <a:endParaRPr lang="en-AU" sz="12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ECB380F-20C3-49B2-B46C-24596BD55F03}"/>
              </a:ext>
            </a:extLst>
          </p:cNvPr>
          <p:cNvSpPr txBox="1"/>
          <p:nvPr/>
        </p:nvSpPr>
        <p:spPr>
          <a:xfrm rot="18613556">
            <a:off x="5562161" y="999134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01</a:t>
            </a:r>
            <a:endParaRPr lang="en-AU" sz="12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AA41064-5020-4271-9D4A-E1CF99AA1677}"/>
              </a:ext>
            </a:extLst>
          </p:cNvPr>
          <p:cNvSpPr txBox="1"/>
          <p:nvPr/>
        </p:nvSpPr>
        <p:spPr>
          <a:xfrm>
            <a:off x="4558255" y="1202860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</a:t>
            </a:r>
            <a:endParaRPr lang="en-AU" sz="1200" b="1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94480D6A-E5CD-4045-A63E-74BBAC0B9A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64659" y="5352526"/>
            <a:ext cx="2267909" cy="3407959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7F5CDFAD-2D52-48B9-9B4F-6D2CE5E7DBE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439" t="3605" r="-10299" b="56740"/>
          <a:stretch/>
        </p:blipFill>
        <p:spPr>
          <a:xfrm>
            <a:off x="4340557" y="4118845"/>
            <a:ext cx="2261127" cy="1084851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B9549F71-9E08-476E-8B4A-1759704100C9}"/>
              </a:ext>
            </a:extLst>
          </p:cNvPr>
          <p:cNvSpPr txBox="1"/>
          <p:nvPr/>
        </p:nvSpPr>
        <p:spPr>
          <a:xfrm>
            <a:off x="4302939" y="4600176"/>
            <a:ext cx="3417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50</a:t>
            </a:r>
          </a:p>
          <a:p>
            <a:endParaRPr lang="en-US" sz="1200" b="1" dirty="0"/>
          </a:p>
          <a:p>
            <a:r>
              <a:rPr lang="en-US" sz="1200" b="1" dirty="0"/>
              <a:t>40</a:t>
            </a:r>
            <a:endParaRPr lang="en-AU" sz="12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A70796A-7EDB-4BF9-A496-F7718F9DD88C}"/>
              </a:ext>
            </a:extLst>
          </p:cNvPr>
          <p:cNvSpPr txBox="1"/>
          <p:nvPr/>
        </p:nvSpPr>
        <p:spPr>
          <a:xfrm rot="18613556">
            <a:off x="4634608" y="380591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MSO</a:t>
            </a:r>
            <a:endParaRPr lang="en-AU" sz="1200" b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F50B0BF-CA4F-4EE6-8FA2-9D14211BCD06}"/>
              </a:ext>
            </a:extLst>
          </p:cNvPr>
          <p:cNvSpPr txBox="1"/>
          <p:nvPr/>
        </p:nvSpPr>
        <p:spPr>
          <a:xfrm rot="18613556">
            <a:off x="4997042" y="3805913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35</a:t>
            </a:r>
            <a:endParaRPr lang="en-AU" sz="12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B253DB2-FCA0-4525-8CA4-4053815572A2}"/>
              </a:ext>
            </a:extLst>
          </p:cNvPr>
          <p:cNvSpPr txBox="1"/>
          <p:nvPr/>
        </p:nvSpPr>
        <p:spPr>
          <a:xfrm rot="18613556">
            <a:off x="5410186" y="3798002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185</a:t>
            </a:r>
            <a:endParaRPr lang="en-AU" sz="1200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A74DDF8-96A8-42AE-9650-29DA312BF040}"/>
              </a:ext>
            </a:extLst>
          </p:cNvPr>
          <p:cNvSpPr txBox="1"/>
          <p:nvPr/>
        </p:nvSpPr>
        <p:spPr>
          <a:xfrm rot="18613556">
            <a:off x="5787250" y="3802427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01</a:t>
            </a:r>
            <a:endParaRPr lang="en-AU" sz="1200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ACFB6B1-A329-4FDA-A6FA-AF2A74F77669}"/>
              </a:ext>
            </a:extLst>
          </p:cNvPr>
          <p:cNvSpPr txBox="1"/>
          <p:nvPr/>
        </p:nvSpPr>
        <p:spPr>
          <a:xfrm rot="18613556">
            <a:off x="5049715" y="532021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MSO</a:t>
            </a:r>
            <a:endParaRPr lang="en-AU" sz="12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956769C-F3D2-490B-B462-E860F928083C}"/>
              </a:ext>
            </a:extLst>
          </p:cNvPr>
          <p:cNvSpPr txBox="1"/>
          <p:nvPr/>
        </p:nvSpPr>
        <p:spPr>
          <a:xfrm rot="18613556">
            <a:off x="5294405" y="5284597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35</a:t>
            </a:r>
            <a:endParaRPr lang="en-AU" sz="12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3597A72-EAC5-4111-BAB6-DE518B7E987D}"/>
              </a:ext>
            </a:extLst>
          </p:cNvPr>
          <p:cNvSpPr txBox="1"/>
          <p:nvPr/>
        </p:nvSpPr>
        <p:spPr>
          <a:xfrm rot="18613556">
            <a:off x="5602731" y="5274849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185</a:t>
            </a:r>
            <a:endParaRPr lang="en-AU" sz="12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5C7C2E9-40FA-4284-84A8-911E7AD5655B}"/>
              </a:ext>
            </a:extLst>
          </p:cNvPr>
          <p:cNvSpPr txBox="1"/>
          <p:nvPr/>
        </p:nvSpPr>
        <p:spPr>
          <a:xfrm rot="18613556">
            <a:off x="5859748" y="5258151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KPT 301</a:t>
            </a:r>
            <a:endParaRPr lang="en-AU" sz="12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069DAFF-3FC0-4108-AD77-F6D60BC7232D}"/>
              </a:ext>
            </a:extLst>
          </p:cNvPr>
          <p:cNvSpPr txBox="1"/>
          <p:nvPr/>
        </p:nvSpPr>
        <p:spPr>
          <a:xfrm>
            <a:off x="4639685" y="5467044"/>
            <a:ext cx="420308" cy="3231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0</a:t>
            </a:r>
          </a:p>
          <a:p>
            <a:r>
              <a:rPr lang="en-US" sz="1200" b="1" dirty="0"/>
              <a:t>125</a:t>
            </a:r>
          </a:p>
          <a:p>
            <a:endParaRPr lang="en-US" sz="1200" b="1" dirty="0"/>
          </a:p>
          <a:p>
            <a:r>
              <a:rPr lang="en-US" sz="1200" b="1" dirty="0"/>
              <a:t>80</a:t>
            </a:r>
          </a:p>
          <a:p>
            <a:endParaRPr lang="en-US" sz="1200" b="1" dirty="0"/>
          </a:p>
          <a:p>
            <a:r>
              <a:rPr lang="en-US" sz="1200" b="1" dirty="0"/>
              <a:t>50</a:t>
            </a:r>
          </a:p>
          <a:p>
            <a:endParaRPr lang="en-US" sz="1200" b="1" dirty="0"/>
          </a:p>
          <a:p>
            <a:r>
              <a:rPr lang="en-US" sz="1200" b="1" dirty="0"/>
              <a:t>40</a:t>
            </a:r>
          </a:p>
          <a:p>
            <a:endParaRPr lang="en-US" sz="1200" b="1" dirty="0"/>
          </a:p>
          <a:p>
            <a:endParaRPr lang="en-US" sz="1200" b="1" dirty="0"/>
          </a:p>
          <a:p>
            <a:r>
              <a:rPr lang="en-US" sz="1200" b="1" dirty="0"/>
              <a:t>25</a:t>
            </a:r>
          </a:p>
          <a:p>
            <a:endParaRPr lang="en-US" sz="1200" b="1" dirty="0"/>
          </a:p>
          <a:p>
            <a:endParaRPr lang="en-US" sz="1200" b="1" dirty="0"/>
          </a:p>
          <a:p>
            <a:r>
              <a:rPr lang="en-US" sz="1200" b="1" dirty="0"/>
              <a:t>20</a:t>
            </a:r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55286529-D0EE-4172-A55F-1277F7FEDE01}"/>
              </a:ext>
            </a:extLst>
          </p:cNvPr>
          <p:cNvGrpSpPr/>
          <p:nvPr/>
        </p:nvGrpSpPr>
        <p:grpSpPr>
          <a:xfrm>
            <a:off x="3554493" y="4643022"/>
            <a:ext cx="740494" cy="276999"/>
            <a:chOff x="3635514" y="1692318"/>
            <a:chExt cx="740494" cy="276999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4D412B06-0168-4350-9AA7-0947C110384D}"/>
                </a:ext>
              </a:extLst>
            </p:cNvPr>
            <p:cNvSpPr txBox="1"/>
            <p:nvPr/>
          </p:nvSpPr>
          <p:spPr>
            <a:xfrm>
              <a:off x="3635514" y="1692318"/>
              <a:ext cx="6640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ubulin</a:t>
              </a:r>
              <a:endParaRPr lang="en-AU" sz="1200" b="1" dirty="0"/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A7CD8B5D-642D-4076-9E3F-11D24AECC80F}"/>
                </a:ext>
              </a:extLst>
            </p:cNvPr>
            <p:cNvCxnSpPr>
              <a:cxnSpLocks/>
            </p:cNvCxnSpPr>
            <p:nvPr/>
          </p:nvCxnSpPr>
          <p:spPr>
            <a:xfrm>
              <a:off x="4283662" y="1830818"/>
              <a:ext cx="92346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C45968A8-5F2C-41E1-A739-72FAEA975675}"/>
              </a:ext>
            </a:extLst>
          </p:cNvPr>
          <p:cNvSpPr txBox="1"/>
          <p:nvPr/>
        </p:nvSpPr>
        <p:spPr>
          <a:xfrm>
            <a:off x="3318312" y="4023276"/>
            <a:ext cx="482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iv)</a:t>
            </a:r>
            <a:endParaRPr lang="en-AU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FE864F8-6CF5-4486-A099-E87734FEF4A0}"/>
              </a:ext>
            </a:extLst>
          </p:cNvPr>
          <p:cNvSpPr txBox="1"/>
          <p:nvPr/>
        </p:nvSpPr>
        <p:spPr>
          <a:xfrm>
            <a:off x="3353635" y="5203945"/>
            <a:ext cx="429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v)</a:t>
            </a:r>
            <a:endParaRPr lang="en-AU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561C31B-16EB-4EE3-B766-84C5DD90DCBB}"/>
              </a:ext>
            </a:extLst>
          </p:cNvPr>
          <p:cNvSpPr txBox="1"/>
          <p:nvPr/>
        </p:nvSpPr>
        <p:spPr>
          <a:xfrm>
            <a:off x="4483208" y="4128814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</a:t>
            </a:r>
            <a:endParaRPr lang="en-AU" sz="1200" b="1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DCD133C-19C3-434B-A34E-C64B68425814}"/>
              </a:ext>
            </a:extLst>
          </p:cNvPr>
          <p:cNvSpPr txBox="1"/>
          <p:nvPr/>
        </p:nvSpPr>
        <p:spPr>
          <a:xfrm>
            <a:off x="4938887" y="5312229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</a:t>
            </a:r>
            <a:endParaRPr lang="en-AU" sz="1200" b="1" dirty="0"/>
          </a:p>
        </p:txBody>
      </p:sp>
      <p:grpSp>
        <p:nvGrpSpPr>
          <p:cNvPr id="74" name="Group 73">
            <a:extLst>
              <a:ext uri="{FF2B5EF4-FFF2-40B4-BE49-F238E27FC236}">
                <a16:creationId xmlns:a16="http://schemas.microsoft.com/office/drawing/2014/main" id="{E925598A-A5CF-4342-8C62-2C1C43232F52}"/>
              </a:ext>
            </a:extLst>
          </p:cNvPr>
          <p:cNvGrpSpPr/>
          <p:nvPr/>
        </p:nvGrpSpPr>
        <p:grpSpPr>
          <a:xfrm>
            <a:off x="3849996" y="6362128"/>
            <a:ext cx="765225" cy="276999"/>
            <a:chOff x="3640565" y="3573807"/>
            <a:chExt cx="765225" cy="276999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C868660-500C-412E-8938-AAAEC9F6D767}"/>
                </a:ext>
              </a:extLst>
            </p:cNvPr>
            <p:cNvSpPr txBox="1"/>
            <p:nvPr/>
          </p:nvSpPr>
          <p:spPr>
            <a:xfrm>
              <a:off x="3640565" y="3573807"/>
              <a:ext cx="6640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ubulin</a:t>
              </a:r>
              <a:endParaRPr lang="en-AU" sz="1200" b="1" dirty="0"/>
            </a:p>
          </p:txBody>
        </p:sp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61B99ABA-A32D-417C-9432-BFD5EA26BBD4}"/>
                </a:ext>
              </a:extLst>
            </p:cNvPr>
            <p:cNvCxnSpPr>
              <a:cxnSpLocks/>
            </p:cNvCxnSpPr>
            <p:nvPr/>
          </p:nvCxnSpPr>
          <p:spPr>
            <a:xfrm>
              <a:off x="4313444" y="3730044"/>
              <a:ext cx="92346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842E2DD6-7781-430A-83B1-CA432FF63BFE}"/>
              </a:ext>
            </a:extLst>
          </p:cNvPr>
          <p:cNvSpPr txBox="1"/>
          <p:nvPr/>
        </p:nvSpPr>
        <p:spPr>
          <a:xfrm>
            <a:off x="3343735" y="170138"/>
            <a:ext cx="9148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8 h.p.t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val="3387817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5F59C130-1F63-4FDE-9072-BC40C623E4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28" t="14498" r="17285" b="19697"/>
          <a:stretch/>
        </p:blipFill>
        <p:spPr>
          <a:xfrm>
            <a:off x="1285112" y="653796"/>
            <a:ext cx="4467225" cy="338137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A902954-853D-4916-8220-27488D8F5705}"/>
              </a:ext>
            </a:extLst>
          </p:cNvPr>
          <p:cNvSpPr/>
          <p:nvPr/>
        </p:nvSpPr>
        <p:spPr>
          <a:xfrm>
            <a:off x="2020062" y="1272921"/>
            <a:ext cx="279557" cy="2000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0A8D9E8-D9A6-4529-9A7A-24BA6C612213}"/>
              </a:ext>
            </a:extLst>
          </p:cNvPr>
          <p:cNvSpPr/>
          <p:nvPr/>
        </p:nvSpPr>
        <p:spPr>
          <a:xfrm>
            <a:off x="3047976" y="1263396"/>
            <a:ext cx="279557" cy="1905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C458E47-38A9-47EF-8282-1194DA032C35}"/>
              </a:ext>
            </a:extLst>
          </p:cNvPr>
          <p:cNvSpPr/>
          <p:nvPr/>
        </p:nvSpPr>
        <p:spPr>
          <a:xfrm>
            <a:off x="4066729" y="1253870"/>
            <a:ext cx="279557" cy="2129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EC1950-F4AA-449B-A5D3-397E2FD0DB8A}"/>
              </a:ext>
            </a:extLst>
          </p:cNvPr>
          <p:cNvSpPr txBox="1"/>
          <p:nvPr/>
        </p:nvSpPr>
        <p:spPr>
          <a:xfrm>
            <a:off x="1561337" y="817790"/>
            <a:ext cx="37887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        M  1    2     3      4      5     6    7    8     9      10  11   12</a:t>
            </a:r>
            <a:endParaRPr lang="en-US" sz="1200" b="1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84A4628-89CA-4D6D-8922-3610387D04D1}"/>
              </a:ext>
            </a:extLst>
          </p:cNvPr>
          <p:cNvSpPr/>
          <p:nvPr/>
        </p:nvSpPr>
        <p:spPr>
          <a:xfrm>
            <a:off x="2550414" y="1266825"/>
            <a:ext cx="279557" cy="2000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A14631A4-CB84-4BBB-A4F9-F5CFE6C138A6}"/>
              </a:ext>
            </a:extLst>
          </p:cNvPr>
          <p:cNvSpPr/>
          <p:nvPr/>
        </p:nvSpPr>
        <p:spPr>
          <a:xfrm>
            <a:off x="3553944" y="1269492"/>
            <a:ext cx="279557" cy="1905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BD5C532-6751-46E9-B1AD-FCEF9602B71E}"/>
              </a:ext>
            </a:extLst>
          </p:cNvPr>
          <p:cNvSpPr txBox="1"/>
          <p:nvPr/>
        </p:nvSpPr>
        <p:spPr>
          <a:xfrm>
            <a:off x="1507938" y="1091433"/>
            <a:ext cx="420308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90</a:t>
            </a:r>
          </a:p>
          <a:p>
            <a:r>
              <a:rPr lang="en-US" sz="1200" b="1" dirty="0"/>
              <a:t>125</a:t>
            </a:r>
          </a:p>
          <a:p>
            <a:r>
              <a:rPr lang="en-US" sz="1200" b="1" dirty="0"/>
              <a:t>80</a:t>
            </a:r>
          </a:p>
          <a:p>
            <a:endParaRPr lang="en-US" sz="1200" b="1" dirty="0"/>
          </a:p>
          <a:p>
            <a:r>
              <a:rPr lang="en-US" sz="1200" b="1" dirty="0"/>
              <a:t>50</a:t>
            </a:r>
          </a:p>
          <a:p>
            <a:endParaRPr lang="en-US" sz="1200" b="1" dirty="0"/>
          </a:p>
          <a:p>
            <a:r>
              <a:rPr lang="en-US" sz="1200" b="1" dirty="0"/>
              <a:t>40</a:t>
            </a:r>
          </a:p>
          <a:p>
            <a:endParaRPr lang="en-US" sz="1200" b="1" dirty="0"/>
          </a:p>
          <a:p>
            <a:r>
              <a:rPr lang="en-US" sz="1200" b="1" dirty="0"/>
              <a:t>25</a:t>
            </a:r>
          </a:p>
          <a:p>
            <a:endParaRPr lang="en-US" sz="1200" b="1" dirty="0"/>
          </a:p>
          <a:p>
            <a:r>
              <a:rPr lang="en-US" sz="1200" b="1" dirty="0"/>
              <a:t>20</a:t>
            </a:r>
          </a:p>
          <a:p>
            <a:endParaRPr lang="en-US" sz="1200" b="1" dirty="0"/>
          </a:p>
          <a:p>
            <a:endParaRPr lang="en-US" sz="1200" b="1" dirty="0"/>
          </a:p>
          <a:p>
            <a:endParaRPr lang="en-US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  <a:p>
            <a:endParaRPr lang="en-AU" sz="12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9C26E89-EE37-4488-A9B8-B22B1A7FBDF3}"/>
              </a:ext>
            </a:extLst>
          </p:cNvPr>
          <p:cNvSpPr txBox="1"/>
          <p:nvPr/>
        </p:nvSpPr>
        <p:spPr>
          <a:xfrm>
            <a:off x="829032" y="1189851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XPO1</a:t>
            </a:r>
            <a:endParaRPr lang="en-AU" sz="1200" b="1" dirty="0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53F866A6-B602-449A-A56E-78D411763093}"/>
              </a:ext>
            </a:extLst>
          </p:cNvPr>
          <p:cNvCxnSpPr>
            <a:cxnSpLocks/>
          </p:cNvCxnSpPr>
          <p:nvPr/>
        </p:nvCxnSpPr>
        <p:spPr>
          <a:xfrm>
            <a:off x="1371675" y="1323254"/>
            <a:ext cx="9234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ACFDFEFE-97D4-466E-8C6F-C6FB72F71524}"/>
              </a:ext>
            </a:extLst>
          </p:cNvPr>
          <p:cNvSpPr/>
          <p:nvPr/>
        </p:nvSpPr>
        <p:spPr>
          <a:xfrm>
            <a:off x="4597081" y="1235582"/>
            <a:ext cx="279557" cy="2129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47EB4F2-7F38-447C-9D0F-25EE9909051D}"/>
              </a:ext>
            </a:extLst>
          </p:cNvPr>
          <p:cNvSpPr txBox="1"/>
          <p:nvPr/>
        </p:nvSpPr>
        <p:spPr>
          <a:xfrm>
            <a:off x="166297" y="67437"/>
            <a:ext cx="2756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A60678B-6793-46BE-A4FD-030DD4ECC60F}"/>
              </a:ext>
            </a:extLst>
          </p:cNvPr>
          <p:cNvSpPr txBox="1"/>
          <p:nvPr/>
        </p:nvSpPr>
        <p:spPr>
          <a:xfrm>
            <a:off x="238543" y="8030971"/>
            <a:ext cx="617797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ull Length Western blots corresponding to  Figure 2C</a:t>
            </a:r>
          </a:p>
          <a:p>
            <a:r>
              <a:rPr lang="en-US" sz="1200" dirty="0"/>
              <a:t>Please refer to Figure 2 for experimental details. M- </a:t>
            </a:r>
            <a:r>
              <a:rPr lang="en-US" sz="1200" dirty="0" err="1"/>
              <a:t>prestained</a:t>
            </a:r>
            <a:r>
              <a:rPr lang="en-US" sz="1200" dirty="0"/>
              <a:t> marker; Molecular weight in </a:t>
            </a:r>
            <a:r>
              <a:rPr lang="en-US" sz="1200" dirty="0" err="1"/>
              <a:t>kDa</a:t>
            </a:r>
            <a:r>
              <a:rPr lang="en-US" sz="1200" dirty="0"/>
              <a:t> is denoted on the left side of the blot. </a:t>
            </a:r>
          </a:p>
          <a:p>
            <a:r>
              <a:rPr lang="en-US" sz="1200" dirty="0"/>
              <a:t>(</a:t>
            </a:r>
            <a:r>
              <a:rPr lang="en-US" sz="1200" dirty="0" err="1"/>
              <a:t>i</a:t>
            </a:r>
            <a:r>
              <a:rPr lang="en-US" sz="1200" dirty="0"/>
              <a:t>) XPO1 at 24  (lanes 1 to 6) and 48 h.p.t (lanes 7 to 12); (ii) Tubulin at 24 (lanes 1 to 6) and 48 h.p.t (lanes 7 to 12).</a:t>
            </a:r>
          </a:p>
          <a:p>
            <a:r>
              <a:rPr lang="en-US" sz="1200" dirty="0"/>
              <a:t>Odd numbered lanes were used in Figure 2C. These are samples collected from </a:t>
            </a:r>
            <a:r>
              <a:rPr lang="en-US" sz="1200" u="sng" dirty="0"/>
              <a:t>non-infected </a:t>
            </a:r>
            <a:r>
              <a:rPr lang="en-US" sz="1200" dirty="0"/>
              <a:t>cells after treatment with DMSO or KPT compounds.</a:t>
            </a:r>
          </a:p>
          <a:p>
            <a:r>
              <a:rPr lang="en-US" sz="1200" dirty="0"/>
              <a:t>Even numbered lanes were not used in figure. These are samples collected from </a:t>
            </a:r>
            <a:r>
              <a:rPr lang="en-US" sz="1200" u="sng" dirty="0"/>
              <a:t>infected</a:t>
            </a:r>
            <a:r>
              <a:rPr lang="en-US" sz="1200" dirty="0"/>
              <a:t> cells after treatment with DMSO or KPT compound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9CB9F34-8B64-4EA3-A799-44F3E439870E}"/>
              </a:ext>
            </a:extLst>
          </p:cNvPr>
          <p:cNvSpPr txBox="1"/>
          <p:nvPr/>
        </p:nvSpPr>
        <p:spPr>
          <a:xfrm>
            <a:off x="564328" y="599316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</a:t>
            </a:r>
            <a:r>
              <a:rPr lang="en-US" dirty="0" err="1"/>
              <a:t>i</a:t>
            </a:r>
            <a:r>
              <a:rPr lang="en-US" dirty="0"/>
              <a:t>)</a:t>
            </a:r>
            <a:endParaRPr lang="en-AU" dirty="0"/>
          </a:p>
        </p:txBody>
      </p:sp>
      <p:pic>
        <p:nvPicPr>
          <p:cNvPr id="48" name="Picture 47" descr="A picture containing text, airplane, smoke&#10;&#10;Description automatically generated">
            <a:extLst>
              <a:ext uri="{FF2B5EF4-FFF2-40B4-BE49-F238E27FC236}">
                <a16:creationId xmlns:a16="http://schemas.microsoft.com/office/drawing/2014/main" id="{EDC46E9D-2066-4EB1-8C06-1471DF4295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5112" y="4121769"/>
            <a:ext cx="4467225" cy="3627339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5A33C5EF-AB4F-46B4-A2E0-CC465F324F52}"/>
              </a:ext>
            </a:extLst>
          </p:cNvPr>
          <p:cNvSpPr txBox="1"/>
          <p:nvPr/>
        </p:nvSpPr>
        <p:spPr>
          <a:xfrm>
            <a:off x="511430" y="4046499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ii)</a:t>
            </a:r>
            <a:endParaRPr lang="en-AU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11ACB96-E107-491D-9E4C-C465DDB0211C}"/>
              </a:ext>
            </a:extLst>
          </p:cNvPr>
          <p:cNvSpPr txBox="1"/>
          <p:nvPr/>
        </p:nvSpPr>
        <p:spPr>
          <a:xfrm>
            <a:off x="1633993" y="4910348"/>
            <a:ext cx="2963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        M  1    2    3   4  5   6   7    8   9  10  11 12</a:t>
            </a:r>
            <a:endParaRPr lang="en-US" sz="12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E1A416C-07CD-4E38-A729-865F301B6ECE}"/>
              </a:ext>
            </a:extLst>
          </p:cNvPr>
          <p:cNvSpPr txBox="1"/>
          <p:nvPr/>
        </p:nvSpPr>
        <p:spPr>
          <a:xfrm>
            <a:off x="1757366" y="5469210"/>
            <a:ext cx="341760" cy="14003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80</a:t>
            </a:r>
          </a:p>
          <a:p>
            <a:endParaRPr lang="en-US" sz="600" b="1" dirty="0"/>
          </a:p>
          <a:p>
            <a:r>
              <a:rPr lang="en-US" sz="1200" b="1" dirty="0"/>
              <a:t>50</a:t>
            </a:r>
          </a:p>
          <a:p>
            <a:endParaRPr lang="en-US" sz="300" b="1" dirty="0"/>
          </a:p>
          <a:p>
            <a:r>
              <a:rPr lang="en-US" sz="1200" b="1" dirty="0"/>
              <a:t>40</a:t>
            </a:r>
          </a:p>
          <a:p>
            <a:endParaRPr lang="en-US" sz="800" b="1" dirty="0"/>
          </a:p>
          <a:p>
            <a:r>
              <a:rPr lang="en-US" sz="1200" b="1" dirty="0"/>
              <a:t>25</a:t>
            </a:r>
          </a:p>
          <a:p>
            <a:endParaRPr lang="en-US" sz="500" b="1" dirty="0"/>
          </a:p>
          <a:p>
            <a:r>
              <a:rPr lang="en-US" sz="1200" b="1" dirty="0"/>
              <a:t>20</a:t>
            </a:r>
            <a:endParaRPr lang="en-AU" sz="1200" b="1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3A23DDD-2270-4E4D-8092-FA6883733420}"/>
              </a:ext>
            </a:extLst>
          </p:cNvPr>
          <p:cNvSpPr/>
          <p:nvPr/>
        </p:nvSpPr>
        <p:spPr>
          <a:xfrm>
            <a:off x="2191843" y="5777276"/>
            <a:ext cx="198554" cy="1100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C9A36C0-EB08-4236-92F8-39C94589C029}"/>
              </a:ext>
            </a:extLst>
          </p:cNvPr>
          <p:cNvSpPr/>
          <p:nvPr/>
        </p:nvSpPr>
        <p:spPr>
          <a:xfrm>
            <a:off x="2942725" y="5745758"/>
            <a:ext cx="155329" cy="1048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6580E85-8EB8-4890-A4BB-B39DEC190FB1}"/>
              </a:ext>
            </a:extLst>
          </p:cNvPr>
          <p:cNvSpPr/>
          <p:nvPr/>
        </p:nvSpPr>
        <p:spPr>
          <a:xfrm>
            <a:off x="3677229" y="5690509"/>
            <a:ext cx="202622" cy="117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561EB88-5E17-4C5F-A71C-F4E05D920FCF}"/>
              </a:ext>
            </a:extLst>
          </p:cNvPr>
          <p:cNvSpPr/>
          <p:nvPr/>
        </p:nvSpPr>
        <p:spPr>
          <a:xfrm>
            <a:off x="2557347" y="5752656"/>
            <a:ext cx="198554" cy="1100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ACD4B94-F0B7-47AC-94A4-742CE2BFDEEB}"/>
              </a:ext>
            </a:extLst>
          </p:cNvPr>
          <p:cNvSpPr/>
          <p:nvPr/>
        </p:nvSpPr>
        <p:spPr>
          <a:xfrm>
            <a:off x="3297300" y="5714980"/>
            <a:ext cx="179326" cy="1048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E91084A-9D24-4EB7-97B1-C830001E1338}"/>
              </a:ext>
            </a:extLst>
          </p:cNvPr>
          <p:cNvSpPr/>
          <p:nvPr/>
        </p:nvSpPr>
        <p:spPr>
          <a:xfrm>
            <a:off x="4063554" y="5660716"/>
            <a:ext cx="202622" cy="1171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54A859A-C2CE-458F-87BD-367B05A79FA8}"/>
              </a:ext>
            </a:extLst>
          </p:cNvPr>
          <p:cNvSpPr txBox="1"/>
          <p:nvPr/>
        </p:nvSpPr>
        <p:spPr>
          <a:xfrm>
            <a:off x="1065014" y="5719078"/>
            <a:ext cx="66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ubulin</a:t>
            </a:r>
            <a:endParaRPr lang="en-AU" sz="1200" b="1" dirty="0"/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9D3FF449-E868-4E3D-ABB4-2F6CF513C7E5}"/>
              </a:ext>
            </a:extLst>
          </p:cNvPr>
          <p:cNvCxnSpPr>
            <a:cxnSpLocks/>
          </p:cNvCxnSpPr>
          <p:nvPr/>
        </p:nvCxnSpPr>
        <p:spPr>
          <a:xfrm>
            <a:off x="1693795" y="5865733"/>
            <a:ext cx="9234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0387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359B30D-EBEA-4BAE-9C8A-7D38FA7A7DD2}"/>
              </a:ext>
            </a:extLst>
          </p:cNvPr>
          <p:cNvSpPr txBox="1"/>
          <p:nvPr/>
        </p:nvSpPr>
        <p:spPr>
          <a:xfrm>
            <a:off x="1067114" y="508443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V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691C491-6EB2-402E-97ED-FBE539BC7EA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7114" y="846997"/>
            <a:ext cx="4358939" cy="434567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EBF33805-99AF-4C93-9ABD-6ED5725D5B2E}"/>
              </a:ext>
            </a:extLst>
          </p:cNvPr>
          <p:cNvCxnSpPr>
            <a:cxnSpLocks/>
          </p:cNvCxnSpPr>
          <p:nvPr/>
        </p:nvCxnSpPr>
        <p:spPr>
          <a:xfrm flipV="1">
            <a:off x="3235054" y="2896595"/>
            <a:ext cx="371536" cy="264430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3E7D2B46-20CC-4254-B76B-D92C3C1BC24C}"/>
              </a:ext>
            </a:extLst>
          </p:cNvPr>
          <p:cNvCxnSpPr>
            <a:cxnSpLocks/>
          </p:cNvCxnSpPr>
          <p:nvPr/>
        </p:nvCxnSpPr>
        <p:spPr>
          <a:xfrm flipV="1">
            <a:off x="3739628" y="3019833"/>
            <a:ext cx="0" cy="396467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AC52C33-992D-4630-A3EC-2D4E5446E9C6}"/>
              </a:ext>
            </a:extLst>
          </p:cNvPr>
          <p:cNvCxnSpPr>
            <a:cxnSpLocks/>
          </p:cNvCxnSpPr>
          <p:nvPr/>
        </p:nvCxnSpPr>
        <p:spPr>
          <a:xfrm flipV="1">
            <a:off x="1968500" y="4152368"/>
            <a:ext cx="286241" cy="17833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Freeform: Shape 6">
            <a:extLst>
              <a:ext uri="{FF2B5EF4-FFF2-40B4-BE49-F238E27FC236}">
                <a16:creationId xmlns:a16="http://schemas.microsoft.com/office/drawing/2014/main" id="{DA1ADEE3-C7A8-47E0-949F-8831112B65E9}"/>
              </a:ext>
            </a:extLst>
          </p:cNvPr>
          <p:cNvSpPr/>
          <p:nvPr/>
        </p:nvSpPr>
        <p:spPr>
          <a:xfrm>
            <a:off x="2273869" y="3993176"/>
            <a:ext cx="155006" cy="200930"/>
          </a:xfrm>
          <a:custGeom>
            <a:avLst/>
            <a:gdLst>
              <a:gd name="connsiteX0" fmla="*/ 105000 w 155006"/>
              <a:gd name="connsiteY0" fmla="*/ 195893 h 200930"/>
              <a:gd name="connsiteX1" fmla="*/ 124050 w 155006"/>
              <a:gd name="connsiteY1" fmla="*/ 191131 h 200930"/>
              <a:gd name="connsiteX2" fmla="*/ 133575 w 155006"/>
              <a:gd name="connsiteY2" fmla="*/ 183987 h 200930"/>
              <a:gd name="connsiteX3" fmla="*/ 140719 w 155006"/>
              <a:gd name="connsiteY3" fmla="*/ 179224 h 200930"/>
              <a:gd name="connsiteX4" fmla="*/ 152625 w 155006"/>
              <a:gd name="connsiteY4" fmla="*/ 164937 h 200930"/>
              <a:gd name="connsiteX5" fmla="*/ 155006 w 155006"/>
              <a:gd name="connsiteY5" fmla="*/ 157793 h 200930"/>
              <a:gd name="connsiteX6" fmla="*/ 152625 w 155006"/>
              <a:gd name="connsiteY6" fmla="*/ 138743 h 200930"/>
              <a:gd name="connsiteX7" fmla="*/ 135956 w 155006"/>
              <a:gd name="connsiteY7" fmla="*/ 119693 h 200930"/>
              <a:gd name="connsiteX8" fmla="*/ 124050 w 155006"/>
              <a:gd name="connsiteY8" fmla="*/ 107787 h 200930"/>
              <a:gd name="connsiteX9" fmla="*/ 119288 w 155006"/>
              <a:gd name="connsiteY9" fmla="*/ 100643 h 200930"/>
              <a:gd name="connsiteX10" fmla="*/ 105000 w 155006"/>
              <a:gd name="connsiteY10" fmla="*/ 91118 h 200930"/>
              <a:gd name="connsiteX11" fmla="*/ 102619 w 155006"/>
              <a:gd name="connsiteY11" fmla="*/ 83974 h 200930"/>
              <a:gd name="connsiteX12" fmla="*/ 95475 w 155006"/>
              <a:gd name="connsiteY12" fmla="*/ 81593 h 200930"/>
              <a:gd name="connsiteX13" fmla="*/ 88331 w 155006"/>
              <a:gd name="connsiteY13" fmla="*/ 76831 h 200930"/>
              <a:gd name="connsiteX14" fmla="*/ 81188 w 155006"/>
              <a:gd name="connsiteY14" fmla="*/ 69687 h 200930"/>
              <a:gd name="connsiteX15" fmla="*/ 71663 w 155006"/>
              <a:gd name="connsiteY15" fmla="*/ 64924 h 200930"/>
              <a:gd name="connsiteX16" fmla="*/ 57375 w 155006"/>
              <a:gd name="connsiteY16" fmla="*/ 55399 h 200930"/>
              <a:gd name="connsiteX17" fmla="*/ 45469 w 155006"/>
              <a:gd name="connsiteY17" fmla="*/ 45874 h 200930"/>
              <a:gd name="connsiteX18" fmla="*/ 31181 w 155006"/>
              <a:gd name="connsiteY18" fmla="*/ 31587 h 200930"/>
              <a:gd name="connsiteX19" fmla="*/ 24038 w 155006"/>
              <a:gd name="connsiteY19" fmla="*/ 26824 h 200930"/>
              <a:gd name="connsiteX20" fmla="*/ 12131 w 155006"/>
              <a:gd name="connsiteY20" fmla="*/ 12537 h 200930"/>
              <a:gd name="connsiteX21" fmla="*/ 4988 w 155006"/>
              <a:gd name="connsiteY21" fmla="*/ 7774 h 200930"/>
              <a:gd name="connsiteX22" fmla="*/ 225 w 155006"/>
              <a:gd name="connsiteY22" fmla="*/ 631 h 200930"/>
              <a:gd name="connsiteX23" fmla="*/ 2606 w 155006"/>
              <a:gd name="connsiteY23" fmla="*/ 45874 h 200930"/>
              <a:gd name="connsiteX24" fmla="*/ 4988 w 155006"/>
              <a:gd name="connsiteY24" fmla="*/ 67306 h 200930"/>
              <a:gd name="connsiteX25" fmla="*/ 9750 w 155006"/>
              <a:gd name="connsiteY25" fmla="*/ 93499 h 200930"/>
              <a:gd name="connsiteX26" fmla="*/ 12131 w 155006"/>
              <a:gd name="connsiteY26" fmla="*/ 103024 h 200930"/>
              <a:gd name="connsiteX27" fmla="*/ 16894 w 155006"/>
              <a:gd name="connsiteY27" fmla="*/ 110168 h 200930"/>
              <a:gd name="connsiteX28" fmla="*/ 26419 w 155006"/>
              <a:gd name="connsiteY28" fmla="*/ 138743 h 200930"/>
              <a:gd name="connsiteX29" fmla="*/ 28800 w 155006"/>
              <a:gd name="connsiteY29" fmla="*/ 145887 h 200930"/>
              <a:gd name="connsiteX30" fmla="*/ 33563 w 155006"/>
              <a:gd name="connsiteY30" fmla="*/ 153031 h 200930"/>
              <a:gd name="connsiteX31" fmla="*/ 43088 w 155006"/>
              <a:gd name="connsiteY31" fmla="*/ 164937 h 200930"/>
              <a:gd name="connsiteX32" fmla="*/ 54994 w 155006"/>
              <a:gd name="connsiteY32" fmla="*/ 186368 h 200930"/>
              <a:gd name="connsiteX33" fmla="*/ 62138 w 155006"/>
              <a:gd name="connsiteY33" fmla="*/ 191131 h 200930"/>
              <a:gd name="connsiteX34" fmla="*/ 76425 w 155006"/>
              <a:gd name="connsiteY34" fmla="*/ 195893 h 200930"/>
              <a:gd name="connsiteX35" fmla="*/ 105000 w 155006"/>
              <a:gd name="connsiteY35" fmla="*/ 195893 h 2009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55006" h="200930">
                <a:moveTo>
                  <a:pt x="105000" y="195893"/>
                </a:moveTo>
                <a:cubicBezTo>
                  <a:pt x="112937" y="195099"/>
                  <a:pt x="120108" y="193383"/>
                  <a:pt x="124050" y="191131"/>
                </a:cubicBezTo>
                <a:cubicBezTo>
                  <a:pt x="127496" y="189162"/>
                  <a:pt x="130346" y="186294"/>
                  <a:pt x="133575" y="183987"/>
                </a:cubicBezTo>
                <a:cubicBezTo>
                  <a:pt x="135904" y="182323"/>
                  <a:pt x="138520" y="181056"/>
                  <a:pt x="140719" y="179224"/>
                </a:cubicBezTo>
                <a:cubicBezTo>
                  <a:pt x="145235" y="175461"/>
                  <a:pt x="149948" y="170291"/>
                  <a:pt x="152625" y="164937"/>
                </a:cubicBezTo>
                <a:cubicBezTo>
                  <a:pt x="153747" y="162692"/>
                  <a:pt x="154212" y="160174"/>
                  <a:pt x="155006" y="157793"/>
                </a:cubicBezTo>
                <a:cubicBezTo>
                  <a:pt x="154212" y="151443"/>
                  <a:pt x="154777" y="144770"/>
                  <a:pt x="152625" y="138743"/>
                </a:cubicBezTo>
                <a:cubicBezTo>
                  <a:pt x="148285" y="126590"/>
                  <a:pt x="144476" y="125373"/>
                  <a:pt x="135956" y="119693"/>
                </a:cubicBezTo>
                <a:cubicBezTo>
                  <a:pt x="123257" y="100642"/>
                  <a:pt x="139925" y="123662"/>
                  <a:pt x="124050" y="107787"/>
                </a:cubicBezTo>
                <a:cubicBezTo>
                  <a:pt x="122026" y="105763"/>
                  <a:pt x="121442" y="102528"/>
                  <a:pt x="119288" y="100643"/>
                </a:cubicBezTo>
                <a:cubicBezTo>
                  <a:pt x="114980" y="96874"/>
                  <a:pt x="105000" y="91118"/>
                  <a:pt x="105000" y="91118"/>
                </a:cubicBezTo>
                <a:cubicBezTo>
                  <a:pt x="104206" y="88737"/>
                  <a:pt x="104394" y="85749"/>
                  <a:pt x="102619" y="83974"/>
                </a:cubicBezTo>
                <a:cubicBezTo>
                  <a:pt x="100844" y="82199"/>
                  <a:pt x="97720" y="82715"/>
                  <a:pt x="95475" y="81593"/>
                </a:cubicBezTo>
                <a:cubicBezTo>
                  <a:pt x="92915" y="80313"/>
                  <a:pt x="90530" y="78663"/>
                  <a:pt x="88331" y="76831"/>
                </a:cubicBezTo>
                <a:cubicBezTo>
                  <a:pt x="85744" y="74675"/>
                  <a:pt x="83928" y="71644"/>
                  <a:pt x="81188" y="69687"/>
                </a:cubicBezTo>
                <a:cubicBezTo>
                  <a:pt x="78299" y="67624"/>
                  <a:pt x="74552" y="66987"/>
                  <a:pt x="71663" y="64924"/>
                </a:cubicBezTo>
                <a:cubicBezTo>
                  <a:pt x="56055" y="53776"/>
                  <a:pt x="72700" y="60509"/>
                  <a:pt x="57375" y="55399"/>
                </a:cubicBezTo>
                <a:cubicBezTo>
                  <a:pt x="44306" y="35796"/>
                  <a:pt x="61393" y="58259"/>
                  <a:pt x="45469" y="45874"/>
                </a:cubicBezTo>
                <a:cubicBezTo>
                  <a:pt x="40153" y="41739"/>
                  <a:pt x="36785" y="35324"/>
                  <a:pt x="31181" y="31587"/>
                </a:cubicBezTo>
                <a:lnTo>
                  <a:pt x="24038" y="26824"/>
                </a:lnTo>
                <a:cubicBezTo>
                  <a:pt x="19354" y="19800"/>
                  <a:pt x="19006" y="18267"/>
                  <a:pt x="12131" y="12537"/>
                </a:cubicBezTo>
                <a:cubicBezTo>
                  <a:pt x="9933" y="10705"/>
                  <a:pt x="7369" y="9362"/>
                  <a:pt x="4988" y="7774"/>
                </a:cubicBezTo>
                <a:cubicBezTo>
                  <a:pt x="3400" y="5393"/>
                  <a:pt x="404" y="-2225"/>
                  <a:pt x="225" y="631"/>
                </a:cubicBezTo>
                <a:cubicBezTo>
                  <a:pt x="-717" y="15703"/>
                  <a:pt x="1530" y="30811"/>
                  <a:pt x="2606" y="45874"/>
                </a:cubicBezTo>
                <a:cubicBezTo>
                  <a:pt x="3118" y="53044"/>
                  <a:pt x="4148" y="60167"/>
                  <a:pt x="4988" y="67306"/>
                </a:cubicBezTo>
                <a:cubicBezTo>
                  <a:pt x="8536" y="97458"/>
                  <a:pt x="5010" y="76908"/>
                  <a:pt x="9750" y="93499"/>
                </a:cubicBezTo>
                <a:cubicBezTo>
                  <a:pt x="10649" y="96646"/>
                  <a:pt x="10842" y="100016"/>
                  <a:pt x="12131" y="103024"/>
                </a:cubicBezTo>
                <a:cubicBezTo>
                  <a:pt x="13258" y="105655"/>
                  <a:pt x="15306" y="107787"/>
                  <a:pt x="16894" y="110168"/>
                </a:cubicBezTo>
                <a:lnTo>
                  <a:pt x="26419" y="138743"/>
                </a:lnTo>
                <a:cubicBezTo>
                  <a:pt x="27213" y="141124"/>
                  <a:pt x="27408" y="143799"/>
                  <a:pt x="28800" y="145887"/>
                </a:cubicBezTo>
                <a:lnTo>
                  <a:pt x="33563" y="153031"/>
                </a:lnTo>
                <a:cubicBezTo>
                  <a:pt x="39548" y="170986"/>
                  <a:pt x="30778" y="149549"/>
                  <a:pt x="43088" y="164937"/>
                </a:cubicBezTo>
                <a:cubicBezTo>
                  <a:pt x="53014" y="177346"/>
                  <a:pt x="30998" y="170370"/>
                  <a:pt x="54994" y="186368"/>
                </a:cubicBezTo>
                <a:cubicBezTo>
                  <a:pt x="57375" y="187956"/>
                  <a:pt x="59523" y="189969"/>
                  <a:pt x="62138" y="191131"/>
                </a:cubicBezTo>
                <a:cubicBezTo>
                  <a:pt x="66725" y="193170"/>
                  <a:pt x="76425" y="195893"/>
                  <a:pt x="76425" y="195893"/>
                </a:cubicBezTo>
                <a:cubicBezTo>
                  <a:pt x="92815" y="206820"/>
                  <a:pt x="97063" y="196687"/>
                  <a:pt x="105000" y="195893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A1C57B27-3FAC-4F02-BDA8-ED13A4B869DD}"/>
              </a:ext>
            </a:extLst>
          </p:cNvPr>
          <p:cNvSpPr/>
          <p:nvPr/>
        </p:nvSpPr>
        <p:spPr>
          <a:xfrm>
            <a:off x="3701528" y="2915002"/>
            <a:ext cx="76200" cy="76607"/>
          </a:xfrm>
          <a:prstGeom prst="ellipse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431A5357-C168-4B1C-89E8-B53088B05BF5}"/>
              </a:ext>
            </a:extLst>
          </p:cNvPr>
          <p:cNvSpPr/>
          <p:nvPr/>
        </p:nvSpPr>
        <p:spPr>
          <a:xfrm>
            <a:off x="3622947" y="2841827"/>
            <a:ext cx="56084" cy="54768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C5A93A-E060-4C63-B06C-FD96F458AAEB}"/>
              </a:ext>
            </a:extLst>
          </p:cNvPr>
          <p:cNvSpPr txBox="1"/>
          <p:nvPr/>
        </p:nvSpPr>
        <p:spPr>
          <a:xfrm>
            <a:off x="438500" y="5635399"/>
            <a:ext cx="598099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/>
              <a:t>Madnified</a:t>
            </a:r>
            <a:r>
              <a:rPr lang="en-GB" sz="1200" b="1" dirty="0"/>
              <a:t> plaque assay image corresponding to Figure 3c.</a:t>
            </a:r>
          </a:p>
          <a:p>
            <a:r>
              <a:rPr lang="en-GB" sz="1200" dirty="0"/>
              <a:t>Please refer to Figure 3 for experimental details. The image shown is of RSV infected cells with no treatment. Red circle with red arrow – pinpoint plaque. White circle with white arrow – medium size plaque. Black outline with black arrow – comet shaped plaque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8F806A-C938-4AFB-B2A7-DAED083B96FA}"/>
              </a:ext>
            </a:extLst>
          </p:cNvPr>
          <p:cNvSpPr txBox="1"/>
          <p:nvPr/>
        </p:nvSpPr>
        <p:spPr>
          <a:xfrm>
            <a:off x="51010" y="102411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18338931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E3925A54-5044-4E2F-8264-DBAD4A43C3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62" t="8337" r="20658" b="25217"/>
          <a:stretch/>
        </p:blipFill>
        <p:spPr>
          <a:xfrm>
            <a:off x="1228579" y="459563"/>
            <a:ext cx="4006212" cy="4428172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5C6DF36-1D8A-4863-938A-2486A9CC61D4}"/>
              </a:ext>
            </a:extLst>
          </p:cNvPr>
          <p:cNvSpPr/>
          <p:nvPr/>
        </p:nvSpPr>
        <p:spPr>
          <a:xfrm>
            <a:off x="1845470" y="1368160"/>
            <a:ext cx="2867774" cy="16650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D3387F8-EC5F-416B-BF63-0AE971C3CFA2}"/>
              </a:ext>
            </a:extLst>
          </p:cNvPr>
          <p:cNvSpPr txBox="1"/>
          <p:nvPr/>
        </p:nvSpPr>
        <p:spPr>
          <a:xfrm>
            <a:off x="1946360" y="812183"/>
            <a:ext cx="2989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KPT 335      KPT 301   KPT 185    Control</a:t>
            </a:r>
            <a:endParaRPr lang="en-AU" sz="12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FE6907-5348-4EE0-B3D2-AEC444C0B423}"/>
              </a:ext>
            </a:extLst>
          </p:cNvPr>
          <p:cNvSpPr txBox="1"/>
          <p:nvPr/>
        </p:nvSpPr>
        <p:spPr>
          <a:xfrm>
            <a:off x="1888592" y="1114477"/>
            <a:ext cx="2781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8       30      48    30      4 8    30      48   30 </a:t>
            </a:r>
            <a:endParaRPr lang="en-AU" sz="1200" b="1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606696E-BE78-48CA-B5B3-4C504DE7A33E}"/>
              </a:ext>
            </a:extLst>
          </p:cNvPr>
          <p:cNvCxnSpPr/>
          <p:nvPr/>
        </p:nvCxnSpPr>
        <p:spPr>
          <a:xfrm>
            <a:off x="2035880" y="1129126"/>
            <a:ext cx="4496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118E9B3-0E05-4AE3-BD06-15437062366C}"/>
              </a:ext>
            </a:extLst>
          </p:cNvPr>
          <p:cNvCxnSpPr/>
          <p:nvPr/>
        </p:nvCxnSpPr>
        <p:spPr>
          <a:xfrm>
            <a:off x="2741583" y="1129126"/>
            <a:ext cx="4496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F7892BD-FA16-423A-B9B2-B835B6B519DD}"/>
              </a:ext>
            </a:extLst>
          </p:cNvPr>
          <p:cNvCxnSpPr/>
          <p:nvPr/>
        </p:nvCxnSpPr>
        <p:spPr>
          <a:xfrm>
            <a:off x="3428999" y="1129126"/>
            <a:ext cx="4496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F434DFD-200E-4516-A4F8-F76569E08985}"/>
              </a:ext>
            </a:extLst>
          </p:cNvPr>
          <p:cNvCxnSpPr/>
          <p:nvPr/>
        </p:nvCxnSpPr>
        <p:spPr>
          <a:xfrm>
            <a:off x="4015608" y="1129126"/>
            <a:ext cx="4496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3" name="Picture 32" descr="A picture containing text, appliance&#10;&#10;Description automatically generated">
            <a:extLst>
              <a:ext uri="{FF2B5EF4-FFF2-40B4-BE49-F238E27FC236}">
                <a16:creationId xmlns:a16="http://schemas.microsoft.com/office/drawing/2014/main" id="{97606E84-8D26-43F0-83D7-1B46FA7AD74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547" b="1"/>
          <a:stretch/>
        </p:blipFill>
        <p:spPr>
          <a:xfrm>
            <a:off x="1389696" y="5670857"/>
            <a:ext cx="4078605" cy="2231307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ADA0196E-59CF-4C7B-B32E-8E87ACF45454}"/>
              </a:ext>
            </a:extLst>
          </p:cNvPr>
          <p:cNvSpPr/>
          <p:nvPr/>
        </p:nvSpPr>
        <p:spPr>
          <a:xfrm>
            <a:off x="1747088" y="5949947"/>
            <a:ext cx="812380" cy="2517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56AC485D-1894-45BC-87DE-C3115B5F3822}"/>
              </a:ext>
            </a:extLst>
          </p:cNvPr>
          <p:cNvSpPr/>
          <p:nvPr/>
        </p:nvSpPr>
        <p:spPr>
          <a:xfrm>
            <a:off x="3404285" y="5864309"/>
            <a:ext cx="812380" cy="2517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D6BF280-3A88-4F0E-80B3-9DCC72B4D18D}"/>
              </a:ext>
            </a:extLst>
          </p:cNvPr>
          <p:cNvSpPr/>
          <p:nvPr/>
        </p:nvSpPr>
        <p:spPr>
          <a:xfrm>
            <a:off x="2806057" y="5949946"/>
            <a:ext cx="489593" cy="2202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86AB7AD-9B4D-4D11-BCB3-F39EB961DD31}"/>
              </a:ext>
            </a:extLst>
          </p:cNvPr>
          <p:cNvSpPr txBox="1"/>
          <p:nvPr/>
        </p:nvSpPr>
        <p:spPr>
          <a:xfrm>
            <a:off x="1747088" y="7807890"/>
            <a:ext cx="3677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 1     2     3       4     5    6   M   7      8   9     10    11  12  M</a:t>
            </a:r>
            <a:endParaRPr lang="en-AU" sz="12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3A36625-5F34-4BB9-BF62-FC6DB858C52E}"/>
              </a:ext>
            </a:extLst>
          </p:cNvPr>
          <p:cNvSpPr txBox="1"/>
          <p:nvPr/>
        </p:nvSpPr>
        <p:spPr>
          <a:xfrm>
            <a:off x="720598" y="462591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</a:t>
            </a:r>
            <a:r>
              <a:rPr lang="en-US" dirty="0" err="1"/>
              <a:t>i</a:t>
            </a:r>
            <a:r>
              <a:rPr lang="en-US" dirty="0"/>
              <a:t>)</a:t>
            </a:r>
            <a:endParaRPr lang="en-AU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A0DC4DD-BC47-44CD-A889-2BD432BECEC3}"/>
              </a:ext>
            </a:extLst>
          </p:cNvPr>
          <p:cNvSpPr txBox="1"/>
          <p:nvPr/>
        </p:nvSpPr>
        <p:spPr>
          <a:xfrm>
            <a:off x="550016" y="5163025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ii)</a:t>
            </a:r>
            <a:endParaRPr lang="en-AU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D4276FA-D9A1-4266-90E7-B303CA967434}"/>
              </a:ext>
            </a:extLst>
          </p:cNvPr>
          <p:cNvSpPr txBox="1"/>
          <p:nvPr/>
        </p:nvSpPr>
        <p:spPr>
          <a:xfrm>
            <a:off x="360283" y="8084889"/>
            <a:ext cx="640235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ull Length Western blots corresponding to  Figure 6</a:t>
            </a:r>
          </a:p>
          <a:p>
            <a:r>
              <a:rPr lang="en-US" sz="1200" dirty="0"/>
              <a:t>Please refer to Figure 6 for experimental details. M- </a:t>
            </a:r>
            <a:r>
              <a:rPr lang="en-US" sz="1200" dirty="0" err="1"/>
              <a:t>prestained</a:t>
            </a:r>
            <a:r>
              <a:rPr lang="en-US" sz="1200" dirty="0"/>
              <a:t> marker.</a:t>
            </a:r>
          </a:p>
          <a:p>
            <a:pPr marL="285750" indent="-285750">
              <a:buAutoNum type="romanLcParenBoth"/>
            </a:pPr>
            <a:r>
              <a:rPr lang="en-US" sz="1200" dirty="0"/>
              <a:t>RSV protein expression at 48 and 30 h.p.i after treatment with KPT compounds or DMSO (Control). Section within the red box is used in Figure 6. </a:t>
            </a:r>
          </a:p>
          <a:p>
            <a:pPr marL="285750" indent="-285750">
              <a:buAutoNum type="romanLcParenBoth"/>
            </a:pPr>
            <a:r>
              <a:rPr lang="en-US" sz="1200" dirty="0"/>
              <a:t>Tubulin expression at 48 and 30 h.p.i in a blot that was cut prior to </a:t>
            </a:r>
            <a:r>
              <a:rPr lang="en-US" sz="1200" dirty="0" err="1"/>
              <a:t>hydridisation</a:t>
            </a:r>
            <a:r>
              <a:rPr lang="en-US" sz="1200" dirty="0"/>
              <a:t>. The red boxed sections were used in figure 6. The remaining lanes are samples of non-infected cells (Lanes 4,10 - 48 hours and Lanes 11, 12 - 30 hours) without treatment (-).</a:t>
            </a:r>
            <a:endParaRPr lang="en-AU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B2AFE14-01AB-4D3F-9339-797F1F0568C0}"/>
              </a:ext>
            </a:extLst>
          </p:cNvPr>
          <p:cNvSpPr txBox="1"/>
          <p:nvPr/>
        </p:nvSpPr>
        <p:spPr>
          <a:xfrm>
            <a:off x="2785092" y="5110060"/>
            <a:ext cx="776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/>
              <a:t>Control</a:t>
            </a:r>
            <a:endParaRPr lang="en-AU" sz="1200" b="1" u="sng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32C594A-1C75-4662-A8FE-A6958C9FFAF4}"/>
              </a:ext>
            </a:extLst>
          </p:cNvPr>
          <p:cNvSpPr txBox="1"/>
          <p:nvPr/>
        </p:nvSpPr>
        <p:spPr>
          <a:xfrm>
            <a:off x="1361711" y="5264202"/>
            <a:ext cx="3739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/>
              <a:t>h.p.i</a:t>
            </a:r>
            <a:r>
              <a:rPr lang="en-US" sz="1200" b="1" dirty="0"/>
              <a:t>   48    30   48  48   48   30      30    48  30  48   30  30   </a:t>
            </a:r>
            <a:endParaRPr lang="en-AU" sz="12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C9502DF-0BF2-4260-A04D-C9505D20D8DB}"/>
              </a:ext>
            </a:extLst>
          </p:cNvPr>
          <p:cNvSpPr txBox="1"/>
          <p:nvPr/>
        </p:nvSpPr>
        <p:spPr>
          <a:xfrm>
            <a:off x="1384553" y="5451887"/>
            <a:ext cx="35511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/>
              <a:t>RSV    +      +      +    -      +     +         +      +    +     -      -     -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A7CB0C1-60BE-485A-A140-E70D6E4379A6}"/>
              </a:ext>
            </a:extLst>
          </p:cNvPr>
          <p:cNvSpPr txBox="1"/>
          <p:nvPr/>
        </p:nvSpPr>
        <p:spPr>
          <a:xfrm>
            <a:off x="1747088" y="5102355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u="sng" dirty="0"/>
              <a:t>KPT 33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93C958A-01F1-481F-8466-0F3745A29D83}"/>
              </a:ext>
            </a:extLst>
          </p:cNvPr>
          <p:cNvSpPr txBox="1"/>
          <p:nvPr/>
        </p:nvSpPr>
        <p:spPr>
          <a:xfrm rot="18502167">
            <a:off x="2236759" y="4980677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/>
              <a:t>KPT 30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59AE13-995D-47B5-8801-F466AC8FFAB5}"/>
              </a:ext>
            </a:extLst>
          </p:cNvPr>
          <p:cNvSpPr txBox="1"/>
          <p:nvPr/>
        </p:nvSpPr>
        <p:spPr>
          <a:xfrm rot="18502167">
            <a:off x="3343321" y="4958975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dirty="0"/>
              <a:t>KPT 30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248C1DB-35C9-447B-85FC-7A2BE5664D00}"/>
              </a:ext>
            </a:extLst>
          </p:cNvPr>
          <p:cNvSpPr txBox="1"/>
          <p:nvPr/>
        </p:nvSpPr>
        <p:spPr>
          <a:xfrm>
            <a:off x="3652195" y="5110816"/>
            <a:ext cx="698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b="1" u="sng" dirty="0"/>
              <a:t>KPT 18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47B6997-EE5B-402D-92A4-DAD1C5F77754}"/>
              </a:ext>
            </a:extLst>
          </p:cNvPr>
          <p:cNvSpPr txBox="1"/>
          <p:nvPr/>
        </p:nvSpPr>
        <p:spPr>
          <a:xfrm>
            <a:off x="32588" y="54361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ure s4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4B73CA6-6888-4FAB-9618-347F167D27DC}"/>
              </a:ext>
            </a:extLst>
          </p:cNvPr>
          <p:cNvCxnSpPr>
            <a:cxnSpLocks/>
          </p:cNvCxnSpPr>
          <p:nvPr/>
        </p:nvCxnSpPr>
        <p:spPr>
          <a:xfrm flipV="1">
            <a:off x="4340334" y="5315707"/>
            <a:ext cx="468159" cy="7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9270D0A-6472-4D8D-97F7-E559EF781F06}"/>
              </a:ext>
            </a:extLst>
          </p:cNvPr>
          <p:cNvSpPr txBox="1"/>
          <p:nvPr/>
        </p:nvSpPr>
        <p:spPr>
          <a:xfrm>
            <a:off x="4438435" y="5027984"/>
            <a:ext cx="2411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b="1"/>
              <a:t>-</a:t>
            </a:r>
            <a:endParaRPr lang="en-AU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3E71C1F-B07F-4418-93F9-16A058D6802C}"/>
              </a:ext>
            </a:extLst>
          </p:cNvPr>
          <p:cNvSpPr txBox="1"/>
          <p:nvPr/>
        </p:nvSpPr>
        <p:spPr>
          <a:xfrm>
            <a:off x="2568920" y="5069474"/>
            <a:ext cx="2571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b="1" dirty="0"/>
              <a:t>-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6028951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A86620A-D200-4AAE-9648-041962D713D5}"/>
              </a:ext>
            </a:extLst>
          </p:cNvPr>
          <p:cNvSpPr txBox="1"/>
          <p:nvPr/>
        </p:nvSpPr>
        <p:spPr>
          <a:xfrm>
            <a:off x="135707" y="733982"/>
            <a:ext cx="3219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able s1. </a:t>
            </a:r>
            <a:r>
              <a:rPr lang="en-US" dirty="0"/>
              <a:t>Viral titre for Figure 4* </a:t>
            </a:r>
            <a:endParaRPr lang="en-AU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EF13C9-F201-4A70-867E-C580294AF232}"/>
              </a:ext>
            </a:extLst>
          </p:cNvPr>
          <p:cNvSpPr txBox="1"/>
          <p:nvPr/>
        </p:nvSpPr>
        <p:spPr>
          <a:xfrm>
            <a:off x="135707" y="3619583"/>
            <a:ext cx="64023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Please refer to Figure 4 for experimental details. RSV titre following treatment with DMSO or SINE compounds.</a:t>
            </a:r>
            <a:endParaRPr lang="en-AU" sz="1400" dirty="0"/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12DB01A1-1D02-4572-B822-92494024E8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8814296"/>
              </p:ext>
            </p:extLst>
          </p:nvPr>
        </p:nvGraphicFramePr>
        <p:xfrm>
          <a:off x="135707" y="1180070"/>
          <a:ext cx="6610864" cy="228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9904">
                  <a:extLst>
                    <a:ext uri="{9D8B030D-6E8A-4147-A177-3AD203B41FA5}">
                      <a16:colId xmlns:a16="http://schemas.microsoft.com/office/drawing/2014/main" val="2842696363"/>
                    </a:ext>
                  </a:extLst>
                </a:gridCol>
                <a:gridCol w="757925">
                  <a:extLst>
                    <a:ext uri="{9D8B030D-6E8A-4147-A177-3AD203B41FA5}">
                      <a16:colId xmlns:a16="http://schemas.microsoft.com/office/drawing/2014/main" val="3519961696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2018873900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2580337823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4148013085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2519618512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1989905553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1034622575"/>
                    </a:ext>
                  </a:extLst>
                </a:gridCol>
                <a:gridCol w="709005">
                  <a:extLst>
                    <a:ext uri="{9D8B030D-6E8A-4147-A177-3AD203B41FA5}">
                      <a16:colId xmlns:a16="http://schemas.microsoft.com/office/drawing/2014/main" val="2031093163"/>
                    </a:ext>
                  </a:extLst>
                </a:gridCol>
              </a:tblGrid>
              <a:tr h="457200">
                <a:tc>
                  <a:txBody>
                    <a:bodyPr/>
                    <a:lstStyle/>
                    <a:p>
                      <a:endParaRPr lang="en-AU" sz="1200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AU" sz="1200" b="1" dirty="0"/>
                        <a:t>Treated from 6 – 18h</a:t>
                      </a:r>
                    </a:p>
                    <a:p>
                      <a:pPr algn="ctr"/>
                      <a:r>
                        <a:rPr lang="en-AU" sz="1200" b="1" dirty="0"/>
                        <a:t>Mean pfu/m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GB" sz="1200" b="1" dirty="0"/>
                        <a:t>Treated from 18-30h</a:t>
                      </a:r>
                    </a:p>
                    <a:p>
                      <a:pPr algn="ctr"/>
                      <a:r>
                        <a:rPr lang="en-GB" sz="1200" b="1" dirty="0"/>
                        <a:t>Mean pfu/m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5896872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r>
                        <a:rPr lang="en-AU" sz="1200" b="1" dirty="0"/>
                        <a:t>Treatme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30h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42925" algn="l"/>
                        </a:tabLs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Relative </a:t>
                      </a:r>
                      <a:r>
                        <a:rPr lang="en-US" sz="120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titre</a:t>
                      </a: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 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48h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Relative </a:t>
                      </a:r>
                      <a:r>
                        <a:rPr lang="en-US" sz="120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titre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30h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Relative </a:t>
                      </a:r>
                      <a:r>
                        <a:rPr lang="en-US" sz="120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titre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48h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Relative </a:t>
                      </a:r>
                      <a:r>
                        <a:rPr lang="en-US" sz="120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titre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3445281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r>
                        <a:rPr lang="en-AU" sz="1200" b="1" dirty="0"/>
                        <a:t>DMSO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1.63E+06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24" marR="8824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1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8.60E+06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24" marR="8824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1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8.29E+05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358" marR="62358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1.00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1.63E+06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358" marR="62358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1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5554224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r>
                        <a:rPr lang="en-AU" sz="1200" b="1" dirty="0"/>
                        <a:t>KPT 18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1.90E+06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24" marR="8824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1.17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3.03E+06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24" marR="8824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0.352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7.05E+05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358" marR="62358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0.85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8.19E+05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358" marR="62358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0.5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9562201"/>
                  </a:ext>
                </a:extLst>
              </a:tr>
              <a:tr h="457200">
                <a:tc>
                  <a:txBody>
                    <a:bodyPr/>
                    <a:lstStyle/>
                    <a:p>
                      <a:r>
                        <a:rPr lang="en-AU" sz="1200" b="1" dirty="0"/>
                        <a:t>KPT 33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1.08E+06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24" marR="8824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>
                          <a:solidFill>
                            <a:sysClr val="windowText" lastClr="000000"/>
                          </a:solidFill>
                          <a:effectLst/>
                        </a:rPr>
                        <a:t>0.664</a:t>
                      </a:r>
                      <a:endParaRPr lang="en-AU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4.28E+06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24" marR="8824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0.497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6.62E+05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358" marR="62358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0.80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6.10E+05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358" marR="62358" marT="882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0.37</a:t>
                      </a:r>
                      <a:endParaRPr lang="en-AU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52496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6577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51</TotalTime>
  <Words>751</Words>
  <Application>Microsoft Office PowerPoint</Application>
  <PresentationFormat>A4 Paper (210x297 mm)</PresentationFormat>
  <Paragraphs>19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ynthia.Mathew</dc:creator>
  <cp:lastModifiedBy>Reena.Ghildyal</cp:lastModifiedBy>
  <cp:revision>30</cp:revision>
  <dcterms:created xsi:type="dcterms:W3CDTF">2021-07-21T00:29:19Z</dcterms:created>
  <dcterms:modified xsi:type="dcterms:W3CDTF">2021-08-23T10:55:16Z</dcterms:modified>
</cp:coreProperties>
</file>